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1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12357290" y="4277539"/>
            <a:ext cx="16397391" cy="9469649"/>
            <a:chOff x="927290" y="5583825"/>
            <a:chExt cx="16397391" cy="9469649"/>
          </a:xfrm>
        </p:grpSpPr>
        <p:sp>
          <p:nvSpPr>
            <p:cNvPr id="24" name="矩形 23"/>
            <p:cNvSpPr/>
            <p:nvPr/>
          </p:nvSpPr>
          <p:spPr>
            <a:xfrm rot="18900000">
              <a:off x="14337966" y="5583825"/>
              <a:ext cx="2986715" cy="10156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431999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C</a:t>
              </a:r>
              <a:r>
                <a:rPr kumimoji="0" lang="el-GR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Δ</a:t>
              </a:r>
              <a:r>
                <a:rPr lang="en-GB" altLang="zh-CN" sz="6000" b="1" i="1" kern="0" dirty="0" err="1">
                  <a:solidFill>
                    <a:prstClr val="black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kumimoji="0" lang="en-GB" altLang="zh-CN" sz="60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 </a:t>
              </a:r>
            </a:p>
          </p:txBody>
        </p:sp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2"/>
            <a:srcRect r="8510"/>
            <a:stretch>
              <a:fillRect/>
            </a:stretch>
          </p:blipFill>
          <p:spPr>
            <a:xfrm>
              <a:off x="6991493" y="7267010"/>
              <a:ext cx="9576000" cy="2972185"/>
            </a:xfrm>
            <a:prstGeom prst="rect">
              <a:avLst/>
            </a:prstGeom>
          </p:spPr>
        </p:pic>
        <p:sp>
          <p:nvSpPr>
            <p:cNvPr id="22" name="矩形 21"/>
            <p:cNvSpPr/>
            <p:nvPr/>
          </p:nvSpPr>
          <p:spPr>
            <a:xfrm rot="18900000">
              <a:off x="8046649" y="5919907"/>
              <a:ext cx="1798890" cy="10156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431999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GX01</a:t>
              </a:r>
              <a:endParaRPr kumimoji="0" lang="en-US" altLang="zh-CN" sz="60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Narrow" panose="020B060602020203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8900000">
              <a:off x="11124176" y="5647147"/>
              <a:ext cx="2531462" cy="10156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431999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Δ</a:t>
              </a:r>
              <a:r>
                <a:rPr lang="en-US" altLang="zh-CN" sz="6000" b="1" i="1" kern="0" dirty="0" err="1">
                  <a:solidFill>
                    <a:prstClr val="black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kumimoji="0" lang="en-GB" altLang="zh-CN" sz="60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Narrow" panose="020B0606020202030204" pitchFamily="34" charset="0"/>
                  <a:ea typeface="宋体" panose="02010600030101010101" pitchFamily="2" charset="-122"/>
                </a:rPr>
                <a:t> </a:t>
              </a:r>
            </a:p>
          </p:txBody>
        </p:sp>
        <p:sp>
          <p:nvSpPr>
            <p:cNvPr id="26" name="矩形 25"/>
            <p:cNvSpPr/>
            <p:nvPr/>
          </p:nvSpPr>
          <p:spPr>
            <a:xfrm>
              <a:off x="3334927" y="8028990"/>
              <a:ext cx="3693640" cy="13234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0" b="1" dirty="0">
                  <a:latin typeface="Arial Narrow" panose="020B0606020202030204" pitchFamily="34" charset="0"/>
                </a:rPr>
                <a:t>protease</a:t>
              </a:r>
              <a:endParaRPr lang="zh-CN" altLang="en-US" sz="8000" b="1" dirty="0">
                <a:latin typeface="Arial Narrow" panose="020B0606020202030204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927290" y="10868383"/>
              <a:ext cx="6314549" cy="13234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0" b="1" dirty="0">
                  <a:latin typeface="Arial Narrow" panose="020B0606020202030204" pitchFamily="34" charset="0"/>
                </a:rPr>
                <a:t>endoglucanase</a:t>
              </a:r>
              <a:endParaRPr lang="zh-CN" altLang="en-US" sz="8000" b="1" dirty="0">
                <a:latin typeface="Arial Narrow" panose="020B0606020202030204" pitchFamily="34" charset="0"/>
              </a:endParaRP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993159" y="10365114"/>
              <a:ext cx="9576000" cy="2348830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5"/>
            <a:srcRect l="3355" t="4710" r="10196" b="18720"/>
            <a:stretch/>
          </p:blipFill>
          <p:spPr>
            <a:xfrm>
              <a:off x="6979920" y="12832082"/>
              <a:ext cx="9576000" cy="2221392"/>
            </a:xfrm>
            <a:prstGeom prst="rect">
              <a:avLst/>
            </a:prstGeom>
          </p:spPr>
        </p:pic>
        <p:sp>
          <p:nvSpPr>
            <p:cNvPr id="17" name="矩形 16"/>
            <p:cNvSpPr/>
            <p:nvPr/>
          </p:nvSpPr>
          <p:spPr>
            <a:xfrm>
              <a:off x="3508450" y="13018637"/>
              <a:ext cx="3507692" cy="13234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0" b="1" dirty="0">
                  <a:latin typeface="Arial Narrow" panose="020B0606020202030204" pitchFamily="34" charset="0"/>
                </a:rPr>
                <a:t>amylase</a:t>
              </a:r>
              <a:endParaRPr lang="zh-CN" altLang="en-US" sz="8000" b="1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8" name="矩形 7"/>
          <p:cNvSpPr/>
          <p:nvPr/>
        </p:nvSpPr>
        <p:spPr>
          <a:xfrm>
            <a:off x="3648228" y="18917332"/>
            <a:ext cx="35445922" cy="118495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200000"/>
              </a:lnSpc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has not influence on activity of extracellular enzymes. Plate assays </a:t>
            </a:r>
            <a:r>
              <a:rPr lang="en-US" altLang="zh-CN" sz="6600" kern="100" dirty="0">
                <a:solidFill>
                  <a:srgbClr val="0000FF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Tang et al., 1991)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ere employed to qualitatively test extracellular enzyme activities. A bacterial culture (2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l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of each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train was spotted onto “protease” plates, “endoglucanase” plates or “amylase” plates and incubated at 28 ℃ for 2 days. The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eletion mutant strain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exhibited similar sizes of clearance zone around the inoculation spot on “protease”, “endoglucanase” or “amylase” plates, compared to the wild-type strain. </a:t>
            </a:r>
          </a:p>
          <a:p>
            <a:pPr algn="just">
              <a:lnSpc>
                <a:spcPct val="200000"/>
              </a:lnSpc>
            </a:pPr>
            <a:r>
              <a:rPr lang="en-GB" sz="2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ng, J.L., Liu, Y.N., Barber, C.E., Dow, J.M., Wootton, J.C. and Daniels, M.J. (1991) Genetic and molecular analysis of a cluster of </a:t>
            </a:r>
            <a:r>
              <a:rPr lang="en-GB" sz="2800" i="1" kern="1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pf</a:t>
            </a:r>
            <a:r>
              <a:rPr lang="en-GB" sz="2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s involved in positive regulation of synthesis of extracellular enzymes and polysaccharide in </a:t>
            </a:r>
            <a:r>
              <a:rPr lang="en-GB" sz="2800" i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Xanthomonas campestris</a:t>
            </a:r>
            <a:r>
              <a:rPr lang="en-GB" sz="2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athovar </a:t>
            </a:r>
            <a:r>
              <a:rPr lang="en-GB" sz="2800" i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ampestris</a:t>
            </a:r>
            <a:r>
              <a:rPr lang="en-GB" sz="2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GB" sz="2800" i="1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lecular and General Genetics</a:t>
            </a:r>
            <a:r>
              <a:rPr lang="en-GB" sz="2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226, 409–417. </a:t>
            </a:r>
            <a:endParaRPr lang="en-GB" sz="2800" kern="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7660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8</TotalTime>
  <Words>187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Arial</vt:lpstr>
      <vt:lpstr>Arial Narrow</vt:lpstr>
      <vt:lpstr>Calibri</vt:lpstr>
      <vt:lpstr>Calibri Light</vt:lpstr>
      <vt:lpstr>Times New Roman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42</cp:revision>
  <dcterms:created xsi:type="dcterms:W3CDTF">2024-03-09T05:50:12Z</dcterms:created>
  <dcterms:modified xsi:type="dcterms:W3CDTF">2025-03-21T08:19:10Z</dcterms:modified>
</cp:coreProperties>
</file>